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FF"/>
    <a:srgbClr val="FFFF99"/>
    <a:srgbClr val="CCFFCC"/>
    <a:srgbClr val="99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73154" autoAdjust="0"/>
  </p:normalViewPr>
  <p:slideViewPr>
    <p:cSldViewPr snapToGrid="0">
      <p:cViewPr varScale="1">
        <p:scale>
          <a:sx n="48" d="100"/>
          <a:sy n="48" d="100"/>
        </p:scale>
        <p:origin x="174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4CC53D-DD65-429B-877E-145A5726FEEC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375432-0546-4C1C-9A2C-1BBA491115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943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(Figure legends)</a:t>
            </a:r>
          </a:p>
          <a:p>
            <a:r>
              <a:rPr kumimoji="1" lang="en-US" altLang="ja-JP" dirty="0"/>
              <a:t>Additional File 1: Figure S1. The prescribed CGA form</a:t>
            </a:r>
          </a:p>
          <a:p>
            <a:r>
              <a:rPr kumimoji="1" lang="en-US" altLang="ja-JP" dirty="0"/>
              <a:t>The prescribed form was completed with many findings from each ESAT professional within the initial 2 days. These information and data were shared among all ESAT members and proved useful for discussion to determine the etiology of ESDED.</a:t>
            </a:r>
          </a:p>
          <a:p>
            <a:r>
              <a:rPr kumimoji="1" lang="en-US" altLang="ja-JP" dirty="0"/>
              <a:t>ACE, Angiotensin converting enzyme; BUN, Blood urea nitrogen; CTR, Cardio thoracic ratio; CRP, C-reactive protein; FAST, Functional assessment staging; HDS-R, Hasegawa dementia rating scale - revised; L-DOPA, L-3,4-dihydroxyphenylalanine; MMSE, Mini–mental state examination; MRI, Magnetic resonance imaging; MWST, Modified water swallowing test; NSAIDs, Non-steroidal anti-inflammatory drugs; OT, Occupational therapist; PPIs, Proton pump inhibitors; PT, Physical therapist; PVH, Periventricular </a:t>
            </a:r>
            <a:r>
              <a:rPr kumimoji="1" lang="en-US" altLang="ja-JP" dirty="0" err="1"/>
              <a:t>hyperintensity</a:t>
            </a:r>
            <a:r>
              <a:rPr kumimoji="1" lang="en-US" altLang="ja-JP" dirty="0"/>
              <a:t>; RSST, Repetitive saliva swallowing test; ST, Speech therapist; T-Cho, Total cholesterol; TSH, Thyroid stimulating hormone; WBC, White blood cells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375432-0546-4C1C-9A2C-1BBA491115F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5695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375432-0546-4C1C-9A2C-1BBA491115F7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592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7370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767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209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33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640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8204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1462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30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942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791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794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81A10-AC6D-4B20-B9AA-6CBB0067BB14}" type="datetimeFigureOut">
              <a:rPr kumimoji="1" lang="ja-JP" altLang="en-US" smtClean="0"/>
              <a:t>2016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6C05E-95DC-4F89-811C-1FF1B46FCC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779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3076654"/>
              </p:ext>
            </p:extLst>
          </p:nvPr>
        </p:nvGraphicFramePr>
        <p:xfrm>
          <a:off x="104500" y="543900"/>
          <a:ext cx="6662060" cy="88182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66206">
                  <a:extLst>
                    <a:ext uri="{9D8B030D-6E8A-4147-A177-3AD203B41FA5}">
                      <a16:colId xmlns:a16="http://schemas.microsoft.com/office/drawing/2014/main" val="3726047427"/>
                    </a:ext>
                  </a:extLst>
                </a:gridCol>
                <a:gridCol w="293819">
                  <a:extLst>
                    <a:ext uri="{9D8B030D-6E8A-4147-A177-3AD203B41FA5}">
                      <a16:colId xmlns:a16="http://schemas.microsoft.com/office/drawing/2014/main" val="2537164760"/>
                    </a:ext>
                  </a:extLst>
                </a:gridCol>
                <a:gridCol w="372387">
                  <a:extLst>
                    <a:ext uri="{9D8B030D-6E8A-4147-A177-3AD203B41FA5}">
                      <a16:colId xmlns:a16="http://schemas.microsoft.com/office/drawing/2014/main" val="705287172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3198184106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1443625871"/>
                    </a:ext>
                  </a:extLst>
                </a:gridCol>
                <a:gridCol w="362837">
                  <a:extLst>
                    <a:ext uri="{9D8B030D-6E8A-4147-A177-3AD203B41FA5}">
                      <a16:colId xmlns:a16="http://schemas.microsoft.com/office/drawing/2014/main" val="4177834842"/>
                    </a:ext>
                  </a:extLst>
                </a:gridCol>
                <a:gridCol w="303369">
                  <a:extLst>
                    <a:ext uri="{9D8B030D-6E8A-4147-A177-3AD203B41FA5}">
                      <a16:colId xmlns:a16="http://schemas.microsoft.com/office/drawing/2014/main" val="1655218557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3669945395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76270027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3457671321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2457423383"/>
                    </a:ext>
                  </a:extLst>
                </a:gridCol>
                <a:gridCol w="666206">
                  <a:extLst>
                    <a:ext uri="{9D8B030D-6E8A-4147-A177-3AD203B41FA5}">
                      <a16:colId xmlns:a16="http://schemas.microsoft.com/office/drawing/2014/main" val="2916257167"/>
                    </a:ext>
                  </a:extLst>
                </a:gridCol>
              </a:tblGrid>
              <a:tr h="143520">
                <a:tc gridSpan="3">
                  <a:txBody>
                    <a:bodyPr/>
                    <a:lstStyle/>
                    <a:p>
                      <a:pPr algn="r"/>
                      <a:r>
                        <a:rPr kumimoji="1" lang="en-US" altLang="ja-JP" sz="800" dirty="0"/>
                        <a:t>ID number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r"/>
                      <a:r>
                        <a:rPr kumimoji="1" lang="en-US" altLang="ja-JP" sz="800" dirty="0"/>
                        <a:t>Assessment date; </a:t>
                      </a:r>
                      <a:r>
                        <a:rPr kumimoji="1" lang="ja-JP" altLang="en-US" sz="800" baseline="0" dirty="0"/>
                        <a:t>  </a:t>
                      </a:r>
                      <a:r>
                        <a:rPr kumimoji="1" lang="en-US" altLang="ja-JP" sz="800" dirty="0"/>
                        <a:t>from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to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7894207"/>
                  </a:ext>
                </a:extLst>
              </a:tr>
              <a:tr h="143520"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Nam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Gender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Ag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Long-term care insuranc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8763591"/>
                  </a:ext>
                </a:extLst>
              </a:tr>
              <a:tr h="143520"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Doctor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Nurs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P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O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S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0755398"/>
                  </a:ext>
                </a:extLst>
              </a:tr>
              <a:tr h="265440"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Diagnosed</a:t>
                      </a:r>
                      <a:r>
                        <a:rPr kumimoji="1" lang="en-US" altLang="ja-JP" sz="800" baseline="0" dirty="0"/>
                        <a:t> disease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Complication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Medical history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407471627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Past pneumonia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r>
                        <a:rPr kumimoji="1" lang="en-US" altLang="ja-JP" sz="800" dirty="0"/>
                        <a:t> None</a:t>
                      </a:r>
                      <a:r>
                        <a:rPr kumimoji="1" lang="en-US" altLang="ja-JP" sz="800" baseline="0" dirty="0"/>
                        <a:t> / one time / two times and over.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Last onset of pneumonia (period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XX months / weeks</a:t>
                      </a:r>
                      <a:r>
                        <a:rPr kumimoji="1" lang="en-US" altLang="ja-JP" sz="800" baseline="0" dirty="0"/>
                        <a:t> / days </a:t>
                      </a:r>
                      <a:r>
                        <a:rPr kumimoji="1" lang="en-US" altLang="ja-JP" sz="800" dirty="0"/>
                        <a:t>ago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2648347429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Body weight</a:t>
                      </a:r>
                      <a:r>
                        <a:rPr kumimoji="1" lang="en-US" altLang="ja-JP" sz="800" baseline="0" dirty="0"/>
                        <a:t> gain / los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The date of recognition of eating problem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XX months /</a:t>
                      </a:r>
                      <a:r>
                        <a:rPr kumimoji="1" lang="en-US" altLang="ja-JP" sz="800" baseline="0" dirty="0"/>
                        <a:t> </a:t>
                      </a:r>
                      <a:r>
                        <a:rPr kumimoji="1" lang="en-US" altLang="ja-JP" sz="800" dirty="0"/>
                        <a:t>weeks</a:t>
                      </a:r>
                      <a:r>
                        <a:rPr kumimoji="1" lang="en-US" altLang="ja-JP" sz="800" baseline="0" dirty="0"/>
                        <a:t> /</a:t>
                      </a:r>
                      <a:r>
                        <a:rPr kumimoji="1" lang="en-US" altLang="ja-JP" sz="800" dirty="0"/>
                        <a:t> days ago</a:t>
                      </a: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1268009443"/>
                  </a:ext>
                </a:extLst>
              </a:tr>
              <a:tr h="158760">
                <a:tc gridSpan="9">
                  <a:txBody>
                    <a:bodyPr/>
                    <a:lstStyle/>
                    <a:p>
                      <a:r>
                        <a:rPr kumimoji="1" lang="en-US" altLang="ja-JP" sz="900" b="1" dirty="0"/>
                        <a:t>Activity and eating conditions at pre-hospitalization and the</a:t>
                      </a:r>
                      <a:r>
                        <a:rPr kumimoji="1" lang="en-US" altLang="ja-JP" sz="900" b="1" baseline="0" dirty="0"/>
                        <a:t> day of assessment</a:t>
                      </a:r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900" b="1" dirty="0"/>
                        <a:t>Medications</a:t>
                      </a:r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151464982"/>
                  </a:ext>
                </a:extLst>
              </a:tr>
              <a:tr h="143520">
                <a:tc gridSpan="4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Pre-hospitalizatio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At the time</a:t>
                      </a:r>
                      <a:r>
                        <a:rPr kumimoji="1" lang="en-US" altLang="ja-JP" sz="800" baseline="0" dirty="0"/>
                        <a:t> of a</a:t>
                      </a:r>
                      <a:r>
                        <a:rPr kumimoji="1" lang="en-US" altLang="ja-JP" sz="800" dirty="0"/>
                        <a:t>ssessmen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Antiplatele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6942753"/>
                  </a:ext>
                </a:extLst>
              </a:tr>
              <a:tr h="143520">
                <a:tc gridSpan="4">
                  <a:txBody>
                    <a:bodyPr/>
                    <a:lstStyle/>
                    <a:p>
                      <a:r>
                        <a:rPr kumimoji="1" lang="en-US" altLang="ja-JP" sz="800" dirty="0"/>
                        <a:t>Residenc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   </a:t>
                      </a:r>
                      <a:r>
                        <a:rPr kumimoji="1" lang="en-US" altLang="ja-JP" sz="800" i="0" dirty="0"/>
                        <a:t>cilostazol</a:t>
                      </a:r>
                      <a:endParaRPr kumimoji="1" lang="ja-JP" altLang="en-US" sz="800" i="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413917"/>
                  </a:ext>
                </a:extLst>
              </a:tr>
              <a:tr h="143520">
                <a:tc gridSpan="4">
                  <a:txBody>
                    <a:bodyPr/>
                    <a:lstStyle/>
                    <a:p>
                      <a:r>
                        <a:rPr kumimoji="1" lang="en-US" altLang="ja-JP" sz="800" dirty="0"/>
                        <a:t>Usage</a:t>
                      </a:r>
                      <a:r>
                        <a:rPr kumimoji="1" lang="ja-JP" altLang="en-US" sz="800" baseline="0" dirty="0"/>
                        <a:t> </a:t>
                      </a:r>
                      <a:r>
                        <a:rPr kumimoji="1" lang="en-US" altLang="ja-JP" sz="800" baseline="0" dirty="0"/>
                        <a:t>of visiting servic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/>
                        <a:t>Antihypertensive</a:t>
                      </a:r>
                      <a:endParaRPr kumimoji="1" lang="ja-JP" altLang="en-US" sz="7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5071322"/>
                  </a:ext>
                </a:extLst>
              </a:tr>
              <a:tr h="265440">
                <a:tc grid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Independence degree of daily living for the disabled elderly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   ACE inhibitor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722782"/>
                  </a:ext>
                </a:extLst>
              </a:tr>
              <a:tr h="265440">
                <a:tc grid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Independence degree of daily living for the demented elderly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  </a:t>
                      </a:r>
                      <a:r>
                        <a:rPr kumimoji="1" lang="ja-JP" altLang="en-US" sz="800" baseline="0" dirty="0"/>
                        <a:t> </a:t>
                      </a:r>
                      <a:r>
                        <a:rPr kumimoji="1" lang="en-US" altLang="ja-JP" sz="800" dirty="0"/>
                        <a:t>β-blocker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3114834"/>
                  </a:ext>
                </a:extLst>
              </a:tr>
              <a:tr h="143520">
                <a:tc gridSpan="4">
                  <a:txBody>
                    <a:bodyPr/>
                    <a:lstStyle/>
                    <a:p>
                      <a:r>
                        <a:rPr kumimoji="1" lang="en-US" altLang="ja-JP" sz="800" dirty="0"/>
                        <a:t>Barthel Index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Antiparkins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323397"/>
                  </a:ext>
                </a:extLst>
              </a:tr>
              <a:tr h="143520">
                <a:tc rowSpan="10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About</a:t>
                      </a:r>
                    </a:p>
                    <a:p>
                      <a:pPr algn="ctr"/>
                      <a:r>
                        <a:rPr kumimoji="1" lang="en-US" altLang="ja-JP" sz="800" dirty="0"/>
                        <a:t>meal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Independence degre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   Amantadine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466291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Postur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   L-DOPA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6027509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Dishes and tools for eating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Hypnotic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3365718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Form of</a:t>
                      </a:r>
                      <a:r>
                        <a:rPr kumimoji="1" lang="en-US" altLang="ja-JP" sz="800" baseline="0" dirty="0"/>
                        <a:t> staple food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50" dirty="0"/>
                        <a:t>Antidepressant</a:t>
                      </a:r>
                      <a:endParaRPr kumimoji="1" lang="ja-JP" altLang="en-US" sz="75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7002928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Form of side dish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Anxiolytic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9317847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Degree of water thicknes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PPI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2174697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Oral intake (staples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H2-blocker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0585544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Oral intake (side dishes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NSAID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589112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Time required to finish eating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50" dirty="0"/>
                        <a:t>Bisphosphonate</a:t>
                      </a:r>
                      <a:endParaRPr kumimoji="1" lang="ja-JP" altLang="en-US" sz="75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709931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>
                    <a:solidFill>
                      <a:srgbClr val="CCFFFF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Preferenc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gridSpan="3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Folic acid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n / off</a:t>
                      </a:r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416377"/>
                  </a:ext>
                </a:extLst>
              </a:tr>
              <a:tr h="158760">
                <a:tc gridSpan="12">
                  <a:txBody>
                    <a:bodyPr/>
                    <a:lstStyle/>
                    <a:p>
                      <a:r>
                        <a:rPr kumimoji="1" lang="en-US" altLang="ja-JP" sz="900" b="1" dirty="0"/>
                        <a:t>Physical, laboratory, and imaging examinations</a:t>
                      </a:r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1893057605"/>
                  </a:ext>
                </a:extLst>
              </a:tr>
              <a:tr h="143520"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Conjunctiva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Respiratory sound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Heart sound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3142946937"/>
                  </a:ext>
                </a:extLst>
              </a:tr>
              <a:tr h="143520"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Bowel sound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Palpation</a:t>
                      </a:r>
                      <a:r>
                        <a:rPr kumimoji="1" lang="en-US" altLang="ja-JP" sz="800" baseline="0" dirty="0"/>
                        <a:t> of abdome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 Edema (site, degree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3558561857"/>
                  </a:ext>
                </a:extLst>
              </a:tr>
              <a:tr h="67320"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3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5886807"/>
                  </a:ext>
                </a:extLst>
              </a:tr>
              <a:tr h="143520">
                <a:tc rowSpan="2"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Urinalysis</a:t>
                      </a:r>
                    </a:p>
                    <a:p>
                      <a:pPr algn="ctr"/>
                      <a:r>
                        <a:rPr kumimoji="1" lang="en-US" altLang="ja-JP" sz="800" dirty="0"/>
                        <a:t>(Qualitative test)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Urine protei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Occult blood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Electrocardiogram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09523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Ketone</a:t>
                      </a:r>
                      <a:r>
                        <a:rPr kumimoji="1" lang="en-US" altLang="ja-JP" sz="800" baseline="0" dirty="0"/>
                        <a:t> body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WBC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Chest X-ray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CTR (%)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247291"/>
                  </a:ext>
                </a:extLst>
              </a:tr>
              <a:tr h="143520">
                <a:tc rowSpan="7"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Blood examina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7"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rowSpan="7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WBC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Hemoglobi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Pleural effus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75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773045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CRP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Albumi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Pulmonary opacity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254573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BU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T-Cho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Gastric</a:t>
                      </a:r>
                      <a:r>
                        <a:rPr kumimoji="1" lang="en-US" altLang="ja-JP" sz="800" baseline="0" dirty="0"/>
                        <a:t> hernia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3722688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Creatinine</a:t>
                      </a: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TSH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Brain MRI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Atrophy of the Hippocampu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674299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Sodium (Na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Free T4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Hydrocephalu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980443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Calcium (Ca)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Folic acid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Degree of PVH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 I / II / III / IV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3998255"/>
                  </a:ext>
                </a:extLst>
              </a:tr>
              <a:tr h="143520">
                <a:tc gridSpan="3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18000" marB="1800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Vitamin B1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Zinc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Other findings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8494064"/>
                  </a:ext>
                </a:extLst>
              </a:tr>
              <a:tr h="158760">
                <a:tc gridSpan="7">
                  <a:txBody>
                    <a:bodyPr/>
                    <a:lstStyle/>
                    <a:p>
                      <a:r>
                        <a:rPr kumimoji="1" lang="en-US" altLang="ja-JP" sz="900" b="1" dirty="0"/>
                        <a:t>Structures and</a:t>
                      </a:r>
                      <a:r>
                        <a:rPr kumimoji="1" lang="en-US" altLang="ja-JP" sz="900" b="1" baseline="0" dirty="0"/>
                        <a:t> </a:t>
                      </a:r>
                      <a:r>
                        <a:rPr kumimoji="1" lang="en-US" altLang="ja-JP" sz="900" b="1" dirty="0"/>
                        <a:t>functions of body</a:t>
                      </a:r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36000"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36000"/>
                </a:tc>
                <a:extLst>
                  <a:ext uri="{0D108BD9-81ED-4DB2-BD59-A6C34878D82A}">
                    <a16:rowId xmlns:a16="http://schemas.microsoft.com/office/drawing/2014/main" val="2499183248"/>
                  </a:ext>
                </a:extLst>
              </a:tr>
              <a:tr h="143520">
                <a:tc gridSpan="7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1) Mental functions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4) Dental and Oral functions 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9831188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/>
                        <a:t> Consciousnes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State of teeth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Number of residual teeth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998333"/>
                  </a:ext>
                </a:extLst>
              </a:tr>
              <a:tr h="143520">
                <a:tc rowSpan="2"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/>
                        <a:t> Cognitive  </a:t>
                      </a:r>
                    </a:p>
                    <a:p>
                      <a:pPr algn="l"/>
                      <a:r>
                        <a:rPr kumimoji="1" lang="en-US" altLang="ja-JP" sz="800" dirty="0"/>
                        <a:t> func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HDS-R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/ 30 scor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Number of functioning teeth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2543334"/>
                  </a:ext>
                </a:extLst>
              </a:tr>
              <a:tr h="143520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/>
                        <a:t>MMS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/ 15 scor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Unstable teeth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5535459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 Vitality index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/ 10 score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Parts of dental bite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7730256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2) Sensory functions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Artificial tooth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have been provided?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Yes</a:t>
                      </a:r>
                      <a:r>
                        <a:rPr kumimoji="1" lang="en-US" altLang="ja-JP" sz="800" baseline="0" dirty="0"/>
                        <a:t> / No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911753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Visual sensa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 Problems</a:t>
                      </a:r>
                      <a:r>
                        <a:rPr kumimoji="1" lang="en-US" altLang="ja-JP" sz="800" baseline="0" dirty="0">
                          <a:solidFill>
                            <a:schemeClr val="bg1"/>
                          </a:solidFill>
                        </a:rPr>
                        <a:t> (unadaptable, </a:t>
                      </a:r>
                      <a:r>
                        <a:rPr kumimoji="1" lang="en-US" altLang="ja-JP" sz="800" baseline="0" dirty="0" err="1">
                          <a:solidFill>
                            <a:schemeClr val="bg1"/>
                          </a:solidFill>
                        </a:rPr>
                        <a:t>etc</a:t>
                      </a:r>
                      <a:r>
                        <a:rPr kumimoji="1" lang="en-US" altLang="ja-JP" sz="800" baseline="0" dirty="0">
                          <a:solidFill>
                            <a:schemeClr val="bg1"/>
                          </a:solidFill>
                        </a:rPr>
                        <a:t>)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5667297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Auditory sensa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Condition of</a:t>
                      </a:r>
                      <a:r>
                        <a:rPr kumimoji="1" lang="en-US" altLang="ja-JP" sz="800" baseline="0" dirty="0">
                          <a:solidFill>
                            <a:schemeClr val="bg1"/>
                          </a:solidFill>
                        </a:rPr>
                        <a:t> cleaning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047280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Gustatory sensa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baseline="0" dirty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Halitosis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Normal / Bad breath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0511541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Olfactory sensation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M</a:t>
                      </a:r>
                      <a:r>
                        <a:rPr kumimoji="1" lang="en-US" altLang="ja-JP" sz="800" baseline="0" dirty="0">
                          <a:solidFill>
                            <a:schemeClr val="bg1"/>
                          </a:solidFill>
                        </a:rPr>
                        <a:t>oisture of oral cavity 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Wet</a:t>
                      </a:r>
                      <a:r>
                        <a:rPr kumimoji="1" lang="en-US" altLang="ja-JP" sz="800" baseline="0" dirty="0"/>
                        <a:t> / Dry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4445343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3) Swallowing functions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Disorder of oral mucosa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8554623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RSST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/>
                        <a:t>/30 seconds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dirty="0">
                          <a:solidFill>
                            <a:schemeClr val="bg1"/>
                          </a:solidFill>
                        </a:rPr>
                        <a:t> Function of the tongue</a:t>
                      </a:r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>
                        <a:solidFill>
                          <a:schemeClr val="bg1"/>
                        </a:solidFill>
                      </a:endParaRPr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146548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MWST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5) FAST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4344786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Food test</a:t>
                      </a:r>
                      <a:endParaRPr kumimoji="1" lang="ja-JP" altLang="en-US" sz="800" dirty="0"/>
                    </a:p>
                  </a:txBody>
                  <a:tcPr marL="18000" marR="18000" marT="10800" marB="1080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/>
                        <a:t>FAST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5467159"/>
                  </a:ext>
                </a:extLst>
              </a:tr>
              <a:tr h="158760">
                <a:tc gridSpan="3">
                  <a:txBody>
                    <a:bodyPr/>
                    <a:lstStyle/>
                    <a:p>
                      <a:r>
                        <a:rPr kumimoji="1" lang="en-US" altLang="ja-JP" sz="900" b="1" dirty="0"/>
                        <a:t>Activity</a:t>
                      </a:r>
                      <a:endParaRPr kumimoji="1" lang="ja-JP" altLang="en-US" sz="9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3832960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1) Communication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8020872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 Understanding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7134718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 Expressio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6774167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 Degree</a:t>
                      </a:r>
                      <a:r>
                        <a:rPr kumimoji="1" lang="en-US" altLang="ja-JP" sz="800" baseline="0" dirty="0"/>
                        <a:t> of a</a:t>
                      </a:r>
                      <a:r>
                        <a:rPr kumimoji="1" lang="en-US" altLang="ja-JP" sz="800" dirty="0"/>
                        <a:t>rticulation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0077217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2) Posture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36000" marR="36000" marT="36000" marB="0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800" b="1" dirty="0"/>
                        <a:t>(3) Other problems</a:t>
                      </a:r>
                      <a:endParaRPr kumimoji="1" lang="ja-JP" altLang="en-US" sz="800" b="1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2988918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dirty="0"/>
                        <a:t> Range of motion of the neck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160792"/>
                  </a:ext>
                </a:extLst>
              </a:tr>
              <a:tr h="143520">
                <a:tc gridSpan="3">
                  <a:txBody>
                    <a:bodyPr/>
                    <a:lstStyle/>
                    <a:p>
                      <a:r>
                        <a:rPr kumimoji="1" lang="en-US" altLang="ja-JP" sz="800" baseline="0" dirty="0"/>
                        <a:t> Duration of stable sitting</a:t>
                      </a:r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36000" marR="36000" marT="36000" marB="0">
                    <a:solidFill>
                      <a:srgbClr val="FFFF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marL="18000" marR="18000" marT="10800" marB="108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3590773"/>
                  </a:ext>
                </a:extLst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35174" y="182880"/>
            <a:ext cx="357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0731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61311" y="1986268"/>
            <a:ext cx="357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6428661"/>
              </p:ext>
            </p:extLst>
          </p:nvPr>
        </p:nvGraphicFramePr>
        <p:xfrm>
          <a:off x="334849" y="2355600"/>
          <a:ext cx="6188303" cy="5331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95925">
                  <a:extLst>
                    <a:ext uri="{9D8B030D-6E8A-4147-A177-3AD203B41FA5}">
                      <a16:colId xmlns:a16="http://schemas.microsoft.com/office/drawing/2014/main" val="3918813085"/>
                    </a:ext>
                  </a:extLst>
                </a:gridCol>
                <a:gridCol w="218660">
                  <a:extLst>
                    <a:ext uri="{9D8B030D-6E8A-4147-A177-3AD203B41FA5}">
                      <a16:colId xmlns:a16="http://schemas.microsoft.com/office/drawing/2014/main" val="1737597867"/>
                    </a:ext>
                  </a:extLst>
                </a:gridCol>
                <a:gridCol w="4337613">
                  <a:extLst>
                    <a:ext uri="{9D8B030D-6E8A-4147-A177-3AD203B41FA5}">
                      <a16:colId xmlns:a16="http://schemas.microsoft.com/office/drawing/2014/main" val="2702366886"/>
                    </a:ext>
                  </a:extLst>
                </a:gridCol>
                <a:gridCol w="636105">
                  <a:extLst>
                    <a:ext uri="{9D8B030D-6E8A-4147-A177-3AD203B41FA5}">
                      <a16:colId xmlns:a16="http://schemas.microsoft.com/office/drawing/2014/main" val="2860590409"/>
                    </a:ext>
                  </a:extLst>
                </a:gridCol>
              </a:tblGrid>
              <a:tr h="1731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Five-stage process</a:t>
                      </a:r>
                      <a:endParaRPr kumimoji="1" lang="ja-JP" altLang="en-US" sz="900" dirty="0"/>
                    </a:p>
                  </a:txBody>
                  <a:tcPr marL="36000" marR="36000" marT="18000" marB="18000" anchor="ctr"/>
                </a:tc>
                <a:tc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Check the left box if the sentence is true for the patient</a:t>
                      </a:r>
                      <a:endParaRPr kumimoji="1" lang="ja-JP" altLang="en-US" sz="900" dirty="0"/>
                    </a:p>
                  </a:txBody>
                  <a:tcPr marL="36000" marR="36000" marT="18000" marB="1800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Total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276708113"/>
                  </a:ext>
                </a:extLst>
              </a:tr>
              <a:tr h="173160">
                <a:tc rowSpan="9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 Anticipatory phase</a:t>
                      </a:r>
                    </a:p>
                  </a:txBody>
                  <a:tcPr marL="36000" marR="36000" marT="18000" marB="18000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level of consciousness is relatively low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rowSpan="9">
                  <a:txBody>
                    <a:bodyPr/>
                    <a:lstStyle/>
                    <a:p>
                      <a:pPr algn="r"/>
                      <a:r>
                        <a:rPr kumimoji="1" lang="en-US" altLang="ja-JP" sz="1100" dirty="0"/>
                        <a:t>/ 9</a:t>
                      </a:r>
                      <a:endParaRPr kumimoji="1" lang="ja-JP" altLang="en-US" sz="1100" dirty="0"/>
                    </a:p>
                  </a:txBody>
                  <a:tcPr marL="36000" marR="36000" marT="18000" marB="18000" anchor="b"/>
                </a:tc>
                <a:extLst>
                  <a:ext uri="{0D108BD9-81ED-4DB2-BD59-A6C34878D82A}">
                    <a16:rowId xmlns:a16="http://schemas.microsoft.com/office/drawing/2014/main" val="4126167519"/>
                  </a:ext>
                </a:extLst>
              </a:tr>
              <a:tr h="31032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doesn't react even if he/she sees a food (declining motivation in response to food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48471402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shows difficulty using tableware (chopsticks, spoon, knife</a:t>
                      </a:r>
                      <a:r>
                        <a:rPr kumimoji="1" lang="en-US" altLang="ja-JP" sz="900" baseline="0" dirty="0"/>
                        <a:t> and </a:t>
                      </a:r>
                      <a:r>
                        <a:rPr kumimoji="1" lang="en-US" altLang="ja-JP" sz="900" dirty="0"/>
                        <a:t>folk, </a:t>
                      </a:r>
                      <a:r>
                        <a:rPr kumimoji="1" lang="en-US" altLang="ja-JP" sz="900" dirty="0" err="1"/>
                        <a:t>etc</a:t>
                      </a:r>
                      <a:r>
                        <a:rPr kumimoji="1" lang="en-US" altLang="ja-JP" sz="900" dirty="0"/>
                        <a:t>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817442067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has a strong attention to food and/or taste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2596391716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shows difficulty maintaining attention to eating during meals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4266261982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places</a:t>
                      </a:r>
                      <a:r>
                        <a:rPr kumimoji="1" lang="en-US" altLang="ja-JP" sz="900" baseline="0" dirty="0"/>
                        <a:t> the</a:t>
                      </a:r>
                      <a:r>
                        <a:rPr kumimoji="1" lang="en-US" altLang="ja-JP" sz="900" dirty="0"/>
                        <a:t> next bite in their mouth before swallowing (fails to</a:t>
                      </a:r>
                      <a:r>
                        <a:rPr kumimoji="1" lang="en-US" altLang="ja-JP" sz="900" baseline="0" dirty="0"/>
                        <a:t> pace</a:t>
                      </a:r>
                      <a:r>
                        <a:rPr kumimoji="1" lang="en-US" altLang="ja-JP" sz="900" dirty="0"/>
                        <a:t> eating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544759785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has difficulty in adjusting the amount of a bite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243991248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Parorexia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2301183659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cannot maintain posture during eat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041170893"/>
                  </a:ext>
                </a:extLst>
              </a:tr>
              <a:tr h="173160"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Preparatory phase</a:t>
                      </a:r>
                      <a:endParaRPr kumimoji="1" lang="ja-JP" altLang="en-US" sz="900" dirty="0"/>
                    </a:p>
                  </a:txBody>
                  <a:tcPr marL="36000" marR="36000" marT="18000" marB="18000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rismus (lockjaw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rowSpan="4">
                  <a:txBody>
                    <a:bodyPr/>
                    <a:lstStyle/>
                    <a:p>
                      <a:pPr algn="r"/>
                      <a:r>
                        <a:rPr kumimoji="1" lang="en-US" altLang="ja-JP" sz="1100" dirty="0"/>
                        <a:t>/ 4</a:t>
                      </a:r>
                      <a:endParaRPr kumimoji="1" lang="ja-JP" altLang="en-US" sz="1100" dirty="0"/>
                    </a:p>
                  </a:txBody>
                  <a:tcPr marL="36000" marR="36000" marT="18000" marB="18000" anchor="b"/>
                </a:tc>
                <a:extLst>
                  <a:ext uri="{0D108BD9-81ED-4DB2-BD59-A6C34878D82A}">
                    <a16:rowId xmlns:a16="http://schemas.microsoft.com/office/drawing/2014/main" val="3158685570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often spills</a:t>
                      </a:r>
                      <a:r>
                        <a:rPr kumimoji="1" lang="ja-JP" altLang="en-US" sz="900" baseline="0" dirty="0"/>
                        <a:t> </a:t>
                      </a:r>
                      <a:r>
                        <a:rPr kumimoji="1" lang="en-US" altLang="ja-JP" sz="900" baseline="0" dirty="0"/>
                        <a:t>content</a:t>
                      </a:r>
                      <a:r>
                        <a:rPr kumimoji="1" lang="en-US" altLang="ja-JP" sz="900" dirty="0"/>
                        <a:t>s from their mouth (fails to</a:t>
                      </a:r>
                      <a:r>
                        <a:rPr kumimoji="1" lang="en-US" altLang="ja-JP" sz="900" baseline="0" dirty="0"/>
                        <a:t> close lips</a:t>
                      </a:r>
                      <a:r>
                        <a:rPr kumimoji="1" lang="en-US" altLang="ja-JP" sz="900" dirty="0"/>
                        <a:t>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2665983530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cannot chew, or his/her chewing is</a:t>
                      </a:r>
                      <a:r>
                        <a:rPr kumimoji="1" lang="en-US" altLang="ja-JP" sz="900" baseline="0" dirty="0"/>
                        <a:t> insufficient</a:t>
                      </a:r>
                      <a:r>
                        <a:rPr kumimoji="1" lang="en-US" altLang="ja-JP" sz="900" dirty="0"/>
                        <a:t>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594367725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always chewing for an extended time before swallow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975325794"/>
                  </a:ext>
                </a:extLst>
              </a:tr>
              <a:tr h="173160"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Oral phase</a:t>
                      </a:r>
                      <a:endParaRPr kumimoji="1" lang="ja-JP" altLang="en-US" sz="900" dirty="0"/>
                    </a:p>
                  </a:txBody>
                  <a:tcPr marL="36000" marR="36000" marT="18000" marB="18000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Chewing is sustained because</a:t>
                      </a:r>
                      <a:r>
                        <a:rPr kumimoji="1" lang="en-US" altLang="ja-JP" sz="900" baseline="0" dirty="0"/>
                        <a:t> food</a:t>
                      </a:r>
                      <a:r>
                        <a:rPr kumimoji="1" lang="en-US" altLang="ja-JP" sz="900" dirty="0"/>
                        <a:t> cannot be sent</a:t>
                      </a:r>
                      <a:r>
                        <a:rPr kumimoji="1" lang="en-US" altLang="ja-JP" sz="900" baseline="0" dirty="0"/>
                        <a:t> into the pharyngolarynx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rowSpan="4">
                  <a:txBody>
                    <a:bodyPr/>
                    <a:lstStyle/>
                    <a:p>
                      <a:pPr algn="r"/>
                      <a:r>
                        <a:rPr kumimoji="1" lang="en-US" altLang="ja-JP" sz="1100" dirty="0"/>
                        <a:t>/ 4</a:t>
                      </a:r>
                      <a:endParaRPr kumimoji="1" lang="ja-JP" altLang="en-US" sz="1100" dirty="0"/>
                    </a:p>
                  </a:txBody>
                  <a:tcPr marL="36000" marR="36000" marT="18000" marB="18000" anchor="b"/>
                </a:tc>
                <a:extLst>
                  <a:ext uri="{0D108BD9-81ED-4DB2-BD59-A6C34878D82A}">
                    <a16:rowId xmlns:a16="http://schemas.microsoft.com/office/drawing/2014/main" val="2419003408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easily chokes during chew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8300863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tries to</a:t>
                      </a:r>
                      <a:r>
                        <a:rPr kumimoji="1" lang="en-US" altLang="ja-JP" sz="900" baseline="0" dirty="0"/>
                        <a:t> r</a:t>
                      </a:r>
                      <a:r>
                        <a:rPr kumimoji="1" lang="en-US" altLang="ja-JP" sz="900" dirty="0"/>
                        <a:t>aise their jaw before swallow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24281055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Food residue in the oral cavity is conspicuous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397062539"/>
                  </a:ext>
                </a:extLst>
              </a:tr>
              <a:tr h="173160">
                <a:tc rowSpan="9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 Pharyngeal phase</a:t>
                      </a:r>
                      <a:endParaRPr kumimoji="1" lang="ja-JP" altLang="en-US" sz="900" dirty="0"/>
                    </a:p>
                  </a:txBody>
                  <a:tcPr marL="36000" marR="36000" marT="18000" marB="18000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Wet hoarseness is audible during meals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rowSpan="9">
                  <a:txBody>
                    <a:bodyPr/>
                    <a:lstStyle/>
                    <a:p>
                      <a:pPr algn="r"/>
                      <a:r>
                        <a:rPr kumimoji="1" lang="en-US" altLang="ja-JP" sz="1100" dirty="0"/>
                        <a:t>/ 9</a:t>
                      </a:r>
                      <a:endParaRPr kumimoji="1" lang="ja-JP" altLang="en-US" sz="1100" dirty="0"/>
                    </a:p>
                  </a:txBody>
                  <a:tcPr marL="36000" marR="36000" marT="18000" marB="18000" anchor="b"/>
                </a:tc>
                <a:extLst>
                  <a:ext uri="{0D108BD9-81ED-4DB2-BD59-A6C34878D82A}">
                    <a16:rowId xmlns:a16="http://schemas.microsoft.com/office/drawing/2014/main" val="3719366940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chokes on saliva, or wet hoarseness is always audible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774213439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has difficulty with expectoration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720551625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The patient needs an extended time to swallow (from start to finish swallowing)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127875333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The patient often chokes during meals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2058963361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The patient often spits out viscous phlegm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567505629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Laryngeal elevation is insufficient at swallow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969126157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The patient complains of abnormal feeling at the pharynx after swallowing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450840816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Food and water come out of the nose during meals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130283433"/>
                  </a:ext>
                </a:extLst>
              </a:tr>
              <a:tr h="173160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Esophageal phase</a:t>
                      </a:r>
                      <a:endParaRPr kumimoji="1" lang="ja-JP" altLang="en-US" sz="900" dirty="0"/>
                    </a:p>
                  </a:txBody>
                  <a:tcPr marL="36000" marR="36000" marT="18000" marB="18000" anchor="ctr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The patient often chokes after lying on the bed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rowSpan="3">
                  <a:txBody>
                    <a:bodyPr/>
                    <a:lstStyle/>
                    <a:p>
                      <a:pPr algn="r"/>
                      <a:r>
                        <a:rPr kumimoji="1" lang="en-US" altLang="ja-JP" sz="1100" dirty="0"/>
                        <a:t>/ 3</a:t>
                      </a:r>
                      <a:endParaRPr kumimoji="1" lang="ja-JP" altLang="en-US" sz="1100" dirty="0"/>
                    </a:p>
                  </a:txBody>
                  <a:tcPr marL="36000" marR="36000" marT="18000" marB="18000" anchor="b"/>
                </a:tc>
                <a:extLst>
                  <a:ext uri="{0D108BD9-81ED-4DB2-BD59-A6C34878D82A}">
                    <a16:rowId xmlns:a16="http://schemas.microsoft.com/office/drawing/2014/main" val="1695415390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The patient often suffers from recurrence of pneumonia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3276316348"/>
                  </a:ext>
                </a:extLst>
              </a:tr>
              <a:tr h="173160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/>
                        <a:t>Swallowed foods may sometimes reflux and vomit.</a:t>
                      </a:r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marL="36000" marR="36000" marT="18000" marB="18000"/>
                </a:tc>
                <a:extLst>
                  <a:ext uri="{0D108BD9-81ED-4DB2-BD59-A6C34878D82A}">
                    <a16:rowId xmlns:a16="http://schemas.microsoft.com/office/drawing/2014/main" val="1704751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06013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</TotalTime>
  <Words>1003</Words>
  <Application>Microsoft Office PowerPoint</Application>
  <PresentationFormat>A4 210 x 297 mm</PresentationFormat>
  <Paragraphs>214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sa Arahata</dc:creator>
  <cp:lastModifiedBy>Masahisa Arahata</cp:lastModifiedBy>
  <cp:revision>81</cp:revision>
  <cp:lastPrinted>2016-11-15T02:57:43Z</cp:lastPrinted>
  <dcterms:created xsi:type="dcterms:W3CDTF">2016-11-12T18:09:54Z</dcterms:created>
  <dcterms:modified xsi:type="dcterms:W3CDTF">2016-12-17T16:15:58Z</dcterms:modified>
</cp:coreProperties>
</file>